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90" y="9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Klikk for å redigere undertittelstil i malen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27752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53718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08367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60944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46102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55553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54915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87308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50031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5820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63439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215B5-2F43-4F7D-B07C-8678C0F1F709}" type="datetimeFigureOut">
              <a:rPr lang="nb-NO" smtClean="0"/>
              <a:t>29.10.201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8AB3C0-1A5B-4E7D-BC62-4201D632888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81900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pe 22"/>
          <p:cNvGrpSpPr/>
          <p:nvPr/>
        </p:nvGrpSpPr>
        <p:grpSpPr>
          <a:xfrm>
            <a:off x="726334" y="1555302"/>
            <a:ext cx="7590082" cy="1467614"/>
            <a:chOff x="726334" y="1555302"/>
            <a:chExt cx="7590082" cy="1467614"/>
          </a:xfrm>
        </p:grpSpPr>
        <p:sp>
          <p:nvSpPr>
            <p:cNvPr id="5" name="TekstSylinder 4"/>
            <p:cNvSpPr txBox="1"/>
            <p:nvPr/>
          </p:nvSpPr>
          <p:spPr>
            <a:xfrm>
              <a:off x="726334" y="1762571"/>
              <a:ext cx="7590082" cy="1260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06045" marR="106045">
                <a:lnSpc>
                  <a:spcPct val="115000"/>
                </a:lnSpc>
                <a:spcAft>
                  <a:spcPts val="0"/>
                </a:spcAft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sz="1100" b="1" dirty="0" smtClean="0">
                  <a:effectLst/>
                  <a:latin typeface="Courier New"/>
                  <a:ea typeface="Times New Roman"/>
                  <a:cs typeface="Times New Roman"/>
                </a:rPr>
                <a:t>Human α  MV-LSPADKTNVKAAWGKVGAHAGEYGAEALERMFLSFPTTKTYFPHF-DLSH-----GSAQVKGHGKKVADALT</a:t>
              </a:r>
              <a:endParaRPr lang="nb-NO" sz="1100" b="1" dirty="0">
                <a:ea typeface="Calibri"/>
                <a:cs typeface="Times New Roman"/>
              </a:endParaRPr>
            </a:p>
            <a:p>
              <a:pPr marL="106045" marR="106045">
                <a:lnSpc>
                  <a:spcPct val="115000"/>
                </a:lnSpc>
                <a:spcAft>
                  <a:spcPts val="0"/>
                </a:spcAft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sz="1100" b="1" dirty="0" smtClean="0">
                  <a:effectLst/>
                  <a:latin typeface="Courier New"/>
                  <a:ea typeface="Times New Roman"/>
                  <a:cs typeface="Times New Roman"/>
                </a:rPr>
                <a:t>Human </a:t>
              </a:r>
              <a:r>
                <a:rPr lang="nb-NO" sz="1100" b="1" dirty="0" smtClean="0">
                  <a:effectLst/>
                  <a:latin typeface="Courier New"/>
                  <a:ea typeface="Times New Roman"/>
                  <a:cs typeface="Times New Roman"/>
                </a:rPr>
                <a:t>β</a:t>
              </a:r>
              <a:r>
                <a:rPr lang="en-US" sz="1100" b="1" dirty="0" smtClean="0">
                  <a:effectLst/>
                  <a:latin typeface="Courier New"/>
                  <a:ea typeface="Times New Roman"/>
                  <a:cs typeface="Times New Roman"/>
                </a:rPr>
                <a:t>  MVHLTPEEKSAVTALWGKV--NVDEVGGEALGRLLVVYPWTQRFFESFGDLSTPDAVMGNPKVKAHGKKVLGAFS</a:t>
              </a:r>
              <a:endParaRPr lang="nb-NO" sz="1100" b="1" dirty="0">
                <a:ea typeface="Calibri"/>
                <a:cs typeface="Times New Roman"/>
              </a:endParaRPr>
            </a:p>
            <a:p>
              <a:pPr marL="106045" marR="106045">
                <a:lnSpc>
                  <a:spcPct val="115000"/>
                </a:lnSpc>
                <a:spcAft>
                  <a:spcPts val="0"/>
                </a:spcAft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sz="1100" b="1" dirty="0" smtClean="0">
                  <a:effectLst/>
                  <a:latin typeface="Courier New"/>
                  <a:ea typeface="Times New Roman"/>
                  <a:cs typeface="Times New Roman"/>
                </a:rPr>
                <a:t>Cod α    MS-LTPKDKATVKLFWGRMSGKAELIGADALSRMLAVYPQTKTYFSHWKSLSP-----</a:t>
              </a:r>
              <a:r>
                <a:rPr lang="en-US" sz="1100" b="1" dirty="0">
                  <a:latin typeface="Courier New"/>
                  <a:ea typeface="Times New Roman"/>
                  <a:cs typeface="Times New Roman"/>
                </a:rPr>
                <a:t>GSPDVKKHGKTIMMGIG</a:t>
              </a:r>
              <a:endParaRPr lang="nb-NO" sz="1100" b="1" dirty="0">
                <a:ea typeface="Calibri"/>
                <a:cs typeface="Times New Roman"/>
              </a:endParaRPr>
            </a:p>
            <a:p>
              <a:pPr marL="106045" marR="106045">
                <a:lnSpc>
                  <a:spcPct val="115000"/>
                </a:lnSpc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sz="1100" b="1" dirty="0" smtClean="0">
                  <a:effectLst/>
                  <a:latin typeface="Courier New"/>
                  <a:ea typeface="Times New Roman"/>
                  <a:cs typeface="Times New Roman"/>
                </a:rPr>
                <a:t>Cod β1   MVEWTAAERRHVEAVWSKI--DIDVCGPLALQRCLIVYPWTQRYFGSFGDLSTDAAIVGN</a:t>
              </a:r>
              <a:r>
                <a:rPr lang="en-US" sz="1100" b="1" dirty="0">
                  <a:latin typeface="Courier New"/>
                  <a:ea typeface="Times New Roman"/>
                  <a:cs typeface="Times New Roman"/>
                </a:rPr>
                <a:t>PKVAAHGVVALTGLR</a:t>
              </a:r>
              <a:endParaRPr lang="nb-NO" sz="1100" b="1" dirty="0">
                <a:ea typeface="Calibri"/>
                <a:cs typeface="Times New Roman"/>
              </a:endParaRPr>
            </a:p>
            <a:p>
              <a:pPr marL="106045" marR="106045">
                <a:lnSpc>
                  <a:spcPct val="115000"/>
                </a:lnSpc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sz="1100" b="1" dirty="0" smtClean="0">
                  <a:latin typeface="Courier New"/>
                  <a:ea typeface="Times New Roman"/>
                  <a:cs typeface="Times New Roman"/>
                </a:rPr>
                <a:t> </a:t>
              </a:r>
              <a:endParaRPr lang="nb-NO" sz="1100" b="1" dirty="0">
                <a:ea typeface="Calibri"/>
                <a:cs typeface="Times New Roman"/>
              </a:endParaRPr>
            </a:p>
            <a:p>
              <a:pPr marL="106045" marR="106045">
                <a:lnSpc>
                  <a:spcPct val="115000"/>
                </a:lnSpc>
                <a:spcAft>
                  <a:spcPts val="0"/>
                </a:spcAft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sz="1100" b="1" dirty="0" smtClean="0">
                  <a:effectLst/>
                  <a:latin typeface="Courier New"/>
                  <a:ea typeface="Times New Roman"/>
                  <a:cs typeface="Times New Roman"/>
                </a:rPr>
                <a:t> </a:t>
              </a:r>
              <a:endParaRPr lang="nb-NO" sz="1100" b="1" dirty="0">
                <a:ea typeface="Calibri"/>
                <a:cs typeface="Times New Roman"/>
              </a:endParaRPr>
            </a:p>
          </p:txBody>
        </p:sp>
        <p:grpSp>
          <p:nvGrpSpPr>
            <p:cNvPr id="16" name="Gruppe 15"/>
            <p:cNvGrpSpPr/>
            <p:nvPr/>
          </p:nvGrpSpPr>
          <p:grpSpPr>
            <a:xfrm>
              <a:off x="2000038" y="1555302"/>
              <a:ext cx="5997550" cy="1215584"/>
              <a:chOff x="2000038" y="1555302"/>
              <a:chExt cx="5997550" cy="1215584"/>
            </a:xfrm>
          </p:grpSpPr>
          <p:grpSp>
            <p:nvGrpSpPr>
              <p:cNvPr id="8" name="Gruppe 7"/>
              <p:cNvGrpSpPr/>
              <p:nvPr/>
            </p:nvGrpSpPr>
            <p:grpSpPr>
              <a:xfrm>
                <a:off x="2000038" y="1555302"/>
                <a:ext cx="5997550" cy="248379"/>
                <a:chOff x="2000038" y="1663342"/>
                <a:chExt cx="5997550" cy="248379"/>
              </a:xfrm>
            </p:grpSpPr>
            <p:sp>
              <p:nvSpPr>
                <p:cNvPr id="11" name="Sylinder 10"/>
                <p:cNvSpPr/>
                <p:nvPr/>
              </p:nvSpPr>
              <p:spPr>
                <a:xfrm rot="16200000">
                  <a:off x="7252197" y="1110521"/>
                  <a:ext cx="157909" cy="1332873"/>
                </a:xfrm>
                <a:prstGeom prst="can">
                  <a:avLst/>
                </a:prstGeom>
                <a:gradFill flip="none" rotWithShape="1">
                  <a:gsLst>
                    <a:gs pos="0">
                      <a:schemeClr val="bg1">
                        <a:lumMod val="65000"/>
                      </a:schemeClr>
                    </a:gs>
                    <a:gs pos="50000">
                      <a:schemeClr val="accent1">
                        <a:tint val="44500"/>
                        <a:satMod val="160000"/>
                      </a:schemeClr>
                    </a:gs>
                    <a:gs pos="100000">
                      <a:schemeClr val="accent1">
                        <a:tint val="23500"/>
                        <a:satMod val="160000"/>
                      </a:schemeClr>
                    </a:gs>
                  </a:gsLst>
                  <a:lin ang="0" scaled="0"/>
                  <a:tileRect/>
                </a:gradFill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/>
                </a:p>
              </p:txBody>
            </p:sp>
            <p:sp>
              <p:nvSpPr>
                <p:cNvPr id="14" name="TekstSylinder 13"/>
                <p:cNvSpPr txBox="1"/>
                <p:nvPr/>
              </p:nvSpPr>
              <p:spPr>
                <a:xfrm>
                  <a:off x="7125618" y="1663342"/>
                  <a:ext cx="36004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nb-NO" sz="900" b="1" dirty="0" smtClean="0"/>
                    <a:t>E</a:t>
                  </a:r>
                  <a:endParaRPr lang="nb-NO" sz="900" b="1" dirty="0"/>
                </a:p>
              </p:txBody>
            </p:sp>
            <p:grpSp>
              <p:nvGrpSpPr>
                <p:cNvPr id="3" name="Gruppe 2"/>
                <p:cNvGrpSpPr/>
                <p:nvPr/>
              </p:nvGrpSpPr>
              <p:grpSpPr>
                <a:xfrm>
                  <a:off x="2000038" y="1663342"/>
                  <a:ext cx="1347826" cy="230832"/>
                  <a:chOff x="2381966" y="1613992"/>
                  <a:chExt cx="936101" cy="230832"/>
                </a:xfrm>
              </p:grpSpPr>
              <p:sp>
                <p:nvSpPr>
                  <p:cNvPr id="6" name="Sylinder 5"/>
                  <p:cNvSpPr/>
                  <p:nvPr/>
                </p:nvSpPr>
                <p:spPr>
                  <a:xfrm rot="16200000">
                    <a:off x="2771771" y="1262081"/>
                    <a:ext cx="156492" cy="936101"/>
                  </a:xfrm>
                  <a:prstGeom prst="can">
                    <a:avLst/>
                  </a:prstGeom>
                  <a:gradFill flip="none" rotWithShape="1">
                    <a:gsLst>
                      <a:gs pos="0">
                        <a:schemeClr val="bg1">
                          <a:lumMod val="65000"/>
                        </a:schemeClr>
                      </a:gs>
                      <a:gs pos="50000">
                        <a:schemeClr val="accent1">
                          <a:tint val="44500"/>
                          <a:satMod val="160000"/>
                        </a:schemeClr>
                      </a:gs>
                      <a:gs pos="100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0" scaled="0"/>
                    <a:tileRect/>
                  </a:gradFill>
                  <a:ln w="158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b-NO"/>
                  </a:p>
                </p:txBody>
              </p:sp>
              <p:sp>
                <p:nvSpPr>
                  <p:cNvPr id="12" name="TekstSylinder 11"/>
                  <p:cNvSpPr txBox="1"/>
                  <p:nvPr/>
                </p:nvSpPr>
                <p:spPr>
                  <a:xfrm>
                    <a:off x="2759850" y="1613992"/>
                    <a:ext cx="3600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nb-NO" sz="900" b="1" dirty="0" smtClean="0"/>
                      <a:t>A</a:t>
                    </a:r>
                    <a:endParaRPr lang="nb-NO" sz="900" b="1" dirty="0"/>
                  </a:p>
                </p:txBody>
              </p:sp>
            </p:grpSp>
            <p:grpSp>
              <p:nvGrpSpPr>
                <p:cNvPr id="17" name="Gruppe 16"/>
                <p:cNvGrpSpPr/>
                <p:nvPr/>
              </p:nvGrpSpPr>
              <p:grpSpPr>
                <a:xfrm>
                  <a:off x="3449836" y="1665500"/>
                  <a:ext cx="1361548" cy="246221"/>
                  <a:chOff x="3457965" y="1633765"/>
                  <a:chExt cx="1530034" cy="246221"/>
                </a:xfrm>
              </p:grpSpPr>
              <p:sp>
                <p:nvSpPr>
                  <p:cNvPr id="9" name="Sylinder 8"/>
                  <p:cNvSpPr/>
                  <p:nvPr/>
                </p:nvSpPr>
                <p:spPr>
                  <a:xfrm rot="16200000">
                    <a:off x="4131611" y="996685"/>
                    <a:ext cx="156491" cy="1503783"/>
                  </a:xfrm>
                  <a:prstGeom prst="can">
                    <a:avLst/>
                  </a:prstGeom>
                  <a:gradFill flip="none" rotWithShape="1">
                    <a:gsLst>
                      <a:gs pos="0">
                        <a:schemeClr val="bg1">
                          <a:lumMod val="65000"/>
                        </a:schemeClr>
                      </a:gs>
                      <a:gs pos="50000">
                        <a:schemeClr val="accent1">
                          <a:tint val="44500"/>
                          <a:satMod val="160000"/>
                        </a:schemeClr>
                      </a:gs>
                      <a:gs pos="100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0" scaled="0"/>
                    <a:tileRect/>
                  </a:gradFill>
                  <a:ln w="158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b-NO"/>
                  </a:p>
                </p:txBody>
              </p:sp>
              <p:sp>
                <p:nvSpPr>
                  <p:cNvPr id="13" name="TekstSylinder 12"/>
                  <p:cNvSpPr txBox="1"/>
                  <p:nvPr/>
                </p:nvSpPr>
                <p:spPr>
                  <a:xfrm>
                    <a:off x="4051971" y="1636548"/>
                    <a:ext cx="3600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nb-NO" sz="900" b="1" dirty="0" smtClean="0"/>
                      <a:t>B</a:t>
                    </a:r>
                    <a:endParaRPr lang="nb-NO" sz="900" b="1" dirty="0"/>
                  </a:p>
                </p:txBody>
              </p:sp>
              <p:cxnSp>
                <p:nvCxnSpPr>
                  <p:cNvPr id="32" name="Rett pil 31"/>
                  <p:cNvCxnSpPr/>
                  <p:nvPr/>
                </p:nvCxnSpPr>
                <p:spPr>
                  <a:xfrm flipH="1">
                    <a:off x="4539369" y="1698999"/>
                    <a:ext cx="893" cy="10931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" name="TekstSylinder 50"/>
                  <p:cNvSpPr txBox="1"/>
                  <p:nvPr/>
                </p:nvSpPr>
                <p:spPr>
                  <a:xfrm>
                    <a:off x="4514584" y="1633765"/>
                    <a:ext cx="473415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nb-NO" sz="1000" b="1" dirty="0" smtClean="0"/>
                      <a:t>B12</a:t>
                    </a:r>
                    <a:endParaRPr lang="nb-NO" sz="1000" b="1" dirty="0"/>
                  </a:p>
                </p:txBody>
              </p:sp>
            </p:grpSp>
            <p:grpSp>
              <p:nvGrpSpPr>
                <p:cNvPr id="53" name="Gruppe 52"/>
                <p:cNvGrpSpPr/>
                <p:nvPr/>
              </p:nvGrpSpPr>
              <p:grpSpPr>
                <a:xfrm>
                  <a:off x="4810879" y="1667748"/>
                  <a:ext cx="496915" cy="230832"/>
                  <a:chOff x="2127991" y="3458185"/>
                  <a:chExt cx="496915" cy="230832"/>
                </a:xfrm>
              </p:grpSpPr>
              <p:sp>
                <p:nvSpPr>
                  <p:cNvPr id="54" name="Sylinder 53"/>
                  <p:cNvSpPr/>
                  <p:nvPr/>
                </p:nvSpPr>
                <p:spPr>
                  <a:xfrm rot="16200000">
                    <a:off x="2294502" y="3322088"/>
                    <a:ext cx="163893" cy="496915"/>
                  </a:xfrm>
                  <a:prstGeom prst="can">
                    <a:avLst/>
                  </a:prstGeom>
                  <a:gradFill flip="none" rotWithShape="1">
                    <a:gsLst>
                      <a:gs pos="0">
                        <a:schemeClr val="bg1">
                          <a:lumMod val="65000"/>
                        </a:schemeClr>
                      </a:gs>
                      <a:gs pos="50000">
                        <a:schemeClr val="accent1">
                          <a:tint val="44500"/>
                          <a:satMod val="160000"/>
                        </a:schemeClr>
                      </a:gs>
                      <a:gs pos="100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0" scaled="0"/>
                    <a:tileRect/>
                  </a:gradFill>
                  <a:ln w="158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b-NO"/>
                  </a:p>
                </p:txBody>
              </p:sp>
              <p:sp>
                <p:nvSpPr>
                  <p:cNvPr id="66" name="TekstSylinder 65"/>
                  <p:cNvSpPr txBox="1"/>
                  <p:nvPr/>
                </p:nvSpPr>
                <p:spPr>
                  <a:xfrm>
                    <a:off x="2237849" y="3458185"/>
                    <a:ext cx="3600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nb-NO" sz="900" b="1" dirty="0" smtClean="0"/>
                      <a:t>C</a:t>
                    </a:r>
                    <a:endParaRPr lang="nb-NO" sz="900" b="1" dirty="0"/>
                  </a:p>
                </p:txBody>
              </p:sp>
            </p:grpSp>
            <p:grpSp>
              <p:nvGrpSpPr>
                <p:cNvPr id="67" name="Gruppe 66"/>
                <p:cNvGrpSpPr/>
                <p:nvPr/>
              </p:nvGrpSpPr>
              <p:grpSpPr>
                <a:xfrm>
                  <a:off x="6058143" y="1665500"/>
                  <a:ext cx="576743" cy="230832"/>
                  <a:chOff x="2521477" y="3446888"/>
                  <a:chExt cx="496916" cy="230832"/>
                </a:xfrm>
              </p:grpSpPr>
              <p:sp>
                <p:nvSpPr>
                  <p:cNvPr id="68" name="Sylinder 67"/>
                  <p:cNvSpPr/>
                  <p:nvPr/>
                </p:nvSpPr>
                <p:spPr>
                  <a:xfrm rot="16200000">
                    <a:off x="2691689" y="3318320"/>
                    <a:ext cx="156492" cy="496915"/>
                  </a:xfrm>
                  <a:prstGeom prst="can">
                    <a:avLst/>
                  </a:prstGeom>
                  <a:gradFill flip="none" rotWithShape="1">
                    <a:gsLst>
                      <a:gs pos="0">
                        <a:schemeClr val="bg1">
                          <a:lumMod val="65000"/>
                        </a:schemeClr>
                      </a:gs>
                      <a:gs pos="50000">
                        <a:schemeClr val="accent1">
                          <a:tint val="44500"/>
                          <a:satMod val="160000"/>
                        </a:schemeClr>
                      </a:gs>
                      <a:gs pos="100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0" scaled="0"/>
                    <a:tileRect/>
                  </a:gradFill>
                  <a:ln w="158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b-NO"/>
                  </a:p>
                </p:txBody>
              </p:sp>
              <p:sp>
                <p:nvSpPr>
                  <p:cNvPr id="69" name="TekstSylinder 68"/>
                  <p:cNvSpPr txBox="1"/>
                  <p:nvPr/>
                </p:nvSpPr>
                <p:spPr>
                  <a:xfrm>
                    <a:off x="2658353" y="3446888"/>
                    <a:ext cx="3600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nb-NO" sz="900" b="1" dirty="0" smtClean="0"/>
                      <a:t>D</a:t>
                    </a:r>
                    <a:endParaRPr lang="nb-NO" sz="900" b="1" dirty="0"/>
                  </a:p>
                </p:txBody>
              </p:sp>
            </p:grpSp>
          </p:grpSp>
          <p:cxnSp>
            <p:nvCxnSpPr>
              <p:cNvPr id="7" name="Rett linje 6"/>
              <p:cNvCxnSpPr/>
              <p:nvPr/>
            </p:nvCxnSpPr>
            <p:spPr>
              <a:xfrm flipV="1">
                <a:off x="6436604" y="2523376"/>
                <a:ext cx="137186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Rett linje 37"/>
              <p:cNvCxnSpPr/>
              <p:nvPr/>
            </p:nvCxnSpPr>
            <p:spPr>
              <a:xfrm flipV="1">
                <a:off x="7021916" y="2533199"/>
                <a:ext cx="137186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kstSylinder 17"/>
              <p:cNvSpPr txBox="1"/>
              <p:nvPr/>
            </p:nvSpPr>
            <p:spPr>
              <a:xfrm>
                <a:off x="6404520" y="2502901"/>
                <a:ext cx="28386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11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M</a:t>
                </a:r>
                <a:endParaRPr lang="nb-NO" sz="11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40" name="TekstSylinder 39"/>
              <p:cNvSpPr txBox="1"/>
              <p:nvPr/>
            </p:nvSpPr>
            <p:spPr>
              <a:xfrm>
                <a:off x="6982231" y="2509276"/>
                <a:ext cx="28386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11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K</a:t>
                </a:r>
                <a:endParaRPr lang="nb-NO" sz="11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</p:grpSp>
      </p:grpSp>
      <p:grpSp>
        <p:nvGrpSpPr>
          <p:cNvPr id="19" name="Gruppe 18"/>
          <p:cNvGrpSpPr/>
          <p:nvPr/>
        </p:nvGrpSpPr>
        <p:grpSpPr>
          <a:xfrm>
            <a:off x="716820" y="2834580"/>
            <a:ext cx="7590082" cy="1281847"/>
            <a:chOff x="716820" y="2770885"/>
            <a:chExt cx="7590082" cy="1281847"/>
          </a:xfrm>
        </p:grpSpPr>
        <p:grpSp>
          <p:nvGrpSpPr>
            <p:cNvPr id="21" name="Gruppe 20"/>
            <p:cNvGrpSpPr/>
            <p:nvPr/>
          </p:nvGrpSpPr>
          <p:grpSpPr>
            <a:xfrm>
              <a:off x="716820" y="2770885"/>
              <a:ext cx="7590082" cy="1281847"/>
              <a:chOff x="716820" y="3083767"/>
              <a:chExt cx="7590082" cy="1281847"/>
            </a:xfrm>
          </p:grpSpPr>
          <p:sp>
            <p:nvSpPr>
              <p:cNvPr id="2" name="TekstSylinder 1"/>
              <p:cNvSpPr txBox="1"/>
              <p:nvPr/>
            </p:nvSpPr>
            <p:spPr>
              <a:xfrm>
                <a:off x="716820" y="3299938"/>
                <a:ext cx="7590082" cy="10656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06045" marR="106045" lvl="0">
                  <a:lnSpc>
                    <a:spcPct val="115000"/>
                  </a:lnSpc>
                  <a:tabLst>
                    <a:tab pos="581660" algn="l"/>
                    <a:tab pos="1163320" algn="l"/>
                    <a:tab pos="1744980" algn="l"/>
                    <a:tab pos="2326640" algn="l"/>
                    <a:tab pos="2908300" algn="l"/>
                    <a:tab pos="3489960" algn="l"/>
                    <a:tab pos="4071620" algn="l"/>
                    <a:tab pos="4653280" algn="l"/>
                    <a:tab pos="5234940" algn="l"/>
                    <a:tab pos="5816600" algn="l"/>
                    <a:tab pos="6398260" algn="l"/>
                    <a:tab pos="6979920" algn="l"/>
                    <a:tab pos="7561580" algn="l"/>
                    <a:tab pos="8143240" algn="l"/>
                    <a:tab pos="8724900" algn="l"/>
                    <a:tab pos="9306560" algn="l"/>
                  </a:tabLst>
                </a:pPr>
                <a:r>
                  <a:rPr lang="en-US" sz="1100" b="1" dirty="0">
                    <a:solidFill>
                      <a:prstClr val="black"/>
                    </a:solidFill>
                    <a:latin typeface="Courier New"/>
                    <a:ea typeface="Times New Roman"/>
                    <a:cs typeface="Times New Roman"/>
                  </a:rPr>
                  <a:t>Human α  NAVAHVDDMPNALSALSDLHAHKLRVDPVNFKLLSHCLLVTLAAHLPAEFTPAVHASLDKFLASVSTVLTSKYR</a:t>
                </a:r>
                <a:endParaRPr lang="nb-NO" sz="1100" b="1" dirty="0">
                  <a:solidFill>
                    <a:prstClr val="black"/>
                  </a:solidFill>
                  <a:ea typeface="Calibri"/>
                  <a:cs typeface="Times New Roman"/>
                </a:endParaRPr>
              </a:p>
              <a:p>
                <a:pPr marL="106045" marR="106045" lvl="0">
                  <a:lnSpc>
                    <a:spcPct val="115000"/>
                  </a:lnSpc>
                  <a:tabLst>
                    <a:tab pos="581660" algn="l"/>
                    <a:tab pos="1163320" algn="l"/>
                    <a:tab pos="1744980" algn="l"/>
                    <a:tab pos="2326640" algn="l"/>
                    <a:tab pos="2908300" algn="l"/>
                    <a:tab pos="3489960" algn="l"/>
                    <a:tab pos="4071620" algn="l"/>
                    <a:tab pos="4653280" algn="l"/>
                    <a:tab pos="5234940" algn="l"/>
                    <a:tab pos="5816600" algn="l"/>
                    <a:tab pos="6398260" algn="l"/>
                    <a:tab pos="6979920" algn="l"/>
                    <a:tab pos="7561580" algn="l"/>
                    <a:tab pos="8143240" algn="l"/>
                    <a:tab pos="8724900" algn="l"/>
                    <a:tab pos="9306560" algn="l"/>
                  </a:tabLst>
                </a:pPr>
                <a:r>
                  <a:rPr lang="en-US" sz="1100" b="1" dirty="0">
                    <a:solidFill>
                      <a:prstClr val="black"/>
                    </a:solidFill>
                    <a:latin typeface="Courier New"/>
                    <a:ea typeface="Times New Roman"/>
                    <a:cs typeface="Times New Roman"/>
                  </a:rPr>
                  <a:t>Human </a:t>
                </a:r>
                <a:r>
                  <a:rPr lang="nb-NO" sz="1100" b="1" dirty="0">
                    <a:solidFill>
                      <a:prstClr val="black"/>
                    </a:solidFill>
                    <a:latin typeface="Courier New"/>
                    <a:ea typeface="Times New Roman"/>
                    <a:cs typeface="Times New Roman"/>
                  </a:rPr>
                  <a:t>β</a:t>
                </a:r>
                <a:r>
                  <a:rPr lang="en-US" sz="1100" b="1" dirty="0">
                    <a:solidFill>
                      <a:prstClr val="black"/>
                    </a:solidFill>
                    <a:latin typeface="Courier New"/>
                    <a:ea typeface="Times New Roman"/>
                    <a:cs typeface="Times New Roman"/>
                  </a:rPr>
                  <a:t>  DGLAHLDNLKGTFATLSELHCDKLHVDPENFRLLGNVLVCVLAHHFGKEFTPPVQAAYQKVVAGVANALAHKYH</a:t>
                </a:r>
                <a:endParaRPr lang="nb-NO" sz="1100" b="1" dirty="0">
                  <a:solidFill>
                    <a:prstClr val="black"/>
                  </a:solidFill>
                  <a:ea typeface="Calibri"/>
                  <a:cs typeface="Times New Roman"/>
                </a:endParaRPr>
              </a:p>
              <a:p>
                <a:pPr marL="106045" marR="106045" lvl="0">
                  <a:lnSpc>
                    <a:spcPct val="115000"/>
                  </a:lnSpc>
                  <a:tabLst>
                    <a:tab pos="581660" algn="l"/>
                    <a:tab pos="1163320" algn="l"/>
                    <a:tab pos="1744980" algn="l"/>
                    <a:tab pos="2326640" algn="l"/>
                    <a:tab pos="2908300" algn="l"/>
                    <a:tab pos="3489960" algn="l"/>
                    <a:tab pos="4071620" algn="l"/>
                    <a:tab pos="4653280" algn="l"/>
                    <a:tab pos="5234940" algn="l"/>
                    <a:tab pos="5816600" algn="l"/>
                    <a:tab pos="6398260" algn="l"/>
                    <a:tab pos="6979920" algn="l"/>
                    <a:tab pos="7561580" algn="l"/>
                    <a:tab pos="8143240" algn="l"/>
                    <a:tab pos="8724900" algn="l"/>
                    <a:tab pos="9306560" algn="l"/>
                  </a:tabLst>
                </a:pPr>
                <a:r>
                  <a:rPr lang="en-US" sz="1100" b="1" dirty="0">
                    <a:solidFill>
                      <a:prstClr val="black"/>
                    </a:solidFill>
                    <a:latin typeface="Courier New"/>
                    <a:ea typeface="Times New Roman"/>
                    <a:cs typeface="Times New Roman"/>
                  </a:rPr>
                  <a:t>Cod α    DAVTKMDDLERGLLTLSELHAFKLRVDPTNFKLLSLNILVVMAIMFPDDFTPMAHLAVDKFLCALALALSEKYR</a:t>
                </a:r>
                <a:endParaRPr lang="nb-NO" sz="1100" b="1" dirty="0">
                  <a:solidFill>
                    <a:prstClr val="black"/>
                  </a:solidFill>
                  <a:ea typeface="Calibri"/>
                  <a:cs typeface="Times New Roman"/>
                </a:endParaRPr>
              </a:p>
              <a:p>
                <a:pPr marL="106045" marR="106045" lvl="0">
                  <a:lnSpc>
                    <a:spcPct val="115000"/>
                  </a:lnSpc>
                  <a:tabLst>
                    <a:tab pos="581660" algn="l"/>
                    <a:tab pos="1163320" algn="l"/>
                    <a:tab pos="1744980" algn="l"/>
                    <a:tab pos="2326640" algn="l"/>
                    <a:tab pos="2908300" algn="l"/>
                    <a:tab pos="3489960" algn="l"/>
                    <a:tab pos="4071620" algn="l"/>
                    <a:tab pos="4653280" algn="l"/>
                    <a:tab pos="5234940" algn="l"/>
                    <a:tab pos="5816600" algn="l"/>
                    <a:tab pos="6398260" algn="l"/>
                    <a:tab pos="6979920" algn="l"/>
                    <a:tab pos="7561580" algn="l"/>
                    <a:tab pos="8143240" algn="l"/>
                    <a:tab pos="8724900" algn="l"/>
                    <a:tab pos="9306560" algn="l"/>
                  </a:tabLst>
                </a:pPr>
                <a:r>
                  <a:rPr lang="en-US" sz="1100" b="1" dirty="0" smtClean="0">
                    <a:solidFill>
                      <a:prstClr val="black"/>
                    </a:solidFill>
                    <a:latin typeface="Courier New"/>
                    <a:ea typeface="Times New Roman"/>
                    <a:cs typeface="Times New Roman"/>
                  </a:rPr>
                  <a:t>Cod </a:t>
                </a:r>
                <a:r>
                  <a:rPr lang="en-US" sz="1100" b="1" dirty="0">
                    <a:solidFill>
                      <a:prstClr val="black"/>
                    </a:solidFill>
                    <a:latin typeface="Courier New"/>
                    <a:ea typeface="Times New Roman"/>
                    <a:cs typeface="Times New Roman"/>
                  </a:rPr>
                  <a:t>β1   </a:t>
                </a:r>
                <a:r>
                  <a:rPr lang="en-US" sz="11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ea typeface="Times New Roman"/>
                    <a:cs typeface="Courier New" panose="02070309020205020404" pitchFamily="49" charset="0"/>
                  </a:rPr>
                  <a:t>TALDHMDEIKSTYAALSVLHSEKLHVDPDNFRLLCECLTIVVAGKMGKKLSPEMQAAWQKYLCAVVSALGRQYH</a:t>
                </a:r>
                <a:endParaRPr lang="nb-NO" sz="1100" b="1" dirty="0">
                  <a:solidFill>
                    <a:prstClr val="black"/>
                  </a:solidFill>
                  <a:latin typeface="Courier New" panose="02070309020205020404" pitchFamily="49" charset="0"/>
                  <a:ea typeface="Calibri"/>
                  <a:cs typeface="Courier New" panose="02070309020205020404" pitchFamily="49" charset="0"/>
                </a:endParaRPr>
              </a:p>
              <a:p>
                <a:pPr marL="106045" marR="106045" lvl="0">
                  <a:lnSpc>
                    <a:spcPct val="115000"/>
                  </a:lnSpc>
                  <a:tabLst>
                    <a:tab pos="581660" algn="l"/>
                    <a:tab pos="1163320" algn="l"/>
                    <a:tab pos="1744980" algn="l"/>
                    <a:tab pos="2326640" algn="l"/>
                    <a:tab pos="2908300" algn="l"/>
                    <a:tab pos="3489960" algn="l"/>
                    <a:tab pos="4071620" algn="l"/>
                    <a:tab pos="4653280" algn="l"/>
                    <a:tab pos="5234940" algn="l"/>
                    <a:tab pos="5816600" algn="l"/>
                    <a:tab pos="6398260" algn="l"/>
                    <a:tab pos="6979920" algn="l"/>
                    <a:tab pos="7561580" algn="l"/>
                    <a:tab pos="8143240" algn="l"/>
                    <a:tab pos="8724900" algn="l"/>
                    <a:tab pos="9306560" algn="l"/>
                  </a:tabLst>
                </a:pPr>
                <a:r>
                  <a:rPr lang="nb-NO" sz="11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ea typeface="Calibri"/>
                    <a:cs typeface="Courier New" panose="02070309020205020404" pitchFamily="49" charset="0"/>
                  </a:rPr>
                  <a:t>                                                                                                                                                             </a:t>
                </a:r>
                <a:endParaRPr lang="nb-NO" sz="1100" b="1" dirty="0">
                  <a:solidFill>
                    <a:prstClr val="black"/>
                  </a:solidFill>
                  <a:latin typeface="Courier New" panose="02070309020205020404" pitchFamily="49" charset="0"/>
                  <a:ea typeface="Calibri"/>
                  <a:cs typeface="Courier New" panose="02070309020205020404" pitchFamily="49" charset="0"/>
                </a:endParaRPr>
              </a:p>
            </p:txBody>
          </p:sp>
          <p:grpSp>
            <p:nvGrpSpPr>
              <p:cNvPr id="10" name="Gruppe 9"/>
              <p:cNvGrpSpPr/>
              <p:nvPr/>
            </p:nvGrpSpPr>
            <p:grpSpPr>
              <a:xfrm>
                <a:off x="1658203" y="3083767"/>
                <a:ext cx="5810907" cy="253205"/>
                <a:chOff x="1660429" y="2852935"/>
                <a:chExt cx="5810907" cy="253205"/>
              </a:xfrm>
            </p:grpSpPr>
            <p:cxnSp>
              <p:nvCxnSpPr>
                <p:cNvPr id="50" name="Rett pil 49"/>
                <p:cNvCxnSpPr/>
                <p:nvPr/>
              </p:nvCxnSpPr>
              <p:spPr>
                <a:xfrm flipH="1">
                  <a:off x="5827445" y="2930927"/>
                  <a:ext cx="893" cy="10931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TekstSylinder 63"/>
                <p:cNvSpPr txBox="1"/>
                <p:nvPr/>
              </p:nvSpPr>
              <p:spPr>
                <a:xfrm>
                  <a:off x="5462004" y="2859919"/>
                  <a:ext cx="42985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nb-NO" sz="1000" b="1" dirty="0" smtClean="0"/>
                    <a:t>GH5</a:t>
                  </a:r>
                  <a:endParaRPr lang="nb-NO" sz="1000" b="1" dirty="0"/>
                </a:p>
              </p:txBody>
            </p:sp>
            <p:sp>
              <p:nvSpPr>
                <p:cNvPr id="34" name="Sylinder 33"/>
                <p:cNvSpPr/>
                <p:nvPr/>
              </p:nvSpPr>
              <p:spPr>
                <a:xfrm rot="16200000">
                  <a:off x="1697937" y="2842333"/>
                  <a:ext cx="165432" cy="240448"/>
                </a:xfrm>
                <a:prstGeom prst="can">
                  <a:avLst/>
                </a:prstGeom>
                <a:gradFill flip="none" rotWithShape="1">
                  <a:gsLst>
                    <a:gs pos="0">
                      <a:schemeClr val="bg1">
                        <a:lumMod val="65000"/>
                      </a:schemeClr>
                    </a:gs>
                    <a:gs pos="50000">
                      <a:schemeClr val="accent1">
                        <a:tint val="44500"/>
                        <a:satMod val="160000"/>
                      </a:schemeClr>
                    </a:gs>
                    <a:gs pos="100000">
                      <a:schemeClr val="accent1">
                        <a:tint val="23500"/>
                        <a:satMod val="160000"/>
                      </a:schemeClr>
                    </a:gs>
                  </a:gsLst>
                  <a:lin ang="0" scaled="0"/>
                  <a:tileRect/>
                </a:gradFill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/>
                </a:p>
              </p:txBody>
            </p:sp>
            <p:sp>
              <p:nvSpPr>
                <p:cNvPr id="36" name="Sylinder 35"/>
                <p:cNvSpPr/>
                <p:nvPr/>
              </p:nvSpPr>
              <p:spPr>
                <a:xfrm rot="16200000">
                  <a:off x="4583571" y="2171376"/>
                  <a:ext cx="153863" cy="1593947"/>
                </a:xfrm>
                <a:prstGeom prst="can">
                  <a:avLst/>
                </a:prstGeom>
                <a:gradFill flip="none" rotWithShape="1">
                  <a:gsLst>
                    <a:gs pos="0">
                      <a:schemeClr val="bg1">
                        <a:lumMod val="65000"/>
                      </a:schemeClr>
                    </a:gs>
                    <a:gs pos="50000">
                      <a:schemeClr val="accent1">
                        <a:tint val="44500"/>
                        <a:satMod val="160000"/>
                      </a:schemeClr>
                    </a:gs>
                    <a:gs pos="100000">
                      <a:schemeClr val="accent1">
                        <a:tint val="23500"/>
                        <a:satMod val="160000"/>
                      </a:schemeClr>
                    </a:gs>
                  </a:gsLst>
                  <a:lin ang="0" scaled="0"/>
                  <a:tileRect/>
                </a:gradFill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/>
                </a:p>
              </p:txBody>
            </p:sp>
            <p:grpSp>
              <p:nvGrpSpPr>
                <p:cNvPr id="20" name="Gruppe 19"/>
                <p:cNvGrpSpPr/>
                <p:nvPr/>
              </p:nvGrpSpPr>
              <p:grpSpPr>
                <a:xfrm>
                  <a:off x="2676178" y="2852935"/>
                  <a:ext cx="724341" cy="230832"/>
                  <a:chOff x="2683008" y="3452686"/>
                  <a:chExt cx="724341" cy="230832"/>
                </a:xfrm>
              </p:grpSpPr>
              <p:sp>
                <p:nvSpPr>
                  <p:cNvPr id="35" name="Sylinder 34"/>
                  <p:cNvSpPr/>
                  <p:nvPr/>
                </p:nvSpPr>
                <p:spPr>
                  <a:xfrm rot="16200000">
                    <a:off x="2967762" y="3203778"/>
                    <a:ext cx="154833" cy="724341"/>
                  </a:xfrm>
                  <a:prstGeom prst="can">
                    <a:avLst/>
                  </a:prstGeom>
                  <a:gradFill flip="none" rotWithShape="1">
                    <a:gsLst>
                      <a:gs pos="0">
                        <a:schemeClr val="bg1">
                          <a:lumMod val="65000"/>
                        </a:schemeClr>
                      </a:gs>
                      <a:gs pos="50000">
                        <a:schemeClr val="accent1">
                          <a:tint val="44500"/>
                          <a:satMod val="160000"/>
                        </a:schemeClr>
                      </a:gs>
                      <a:gs pos="100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0" scaled="0"/>
                    <a:tileRect/>
                  </a:gradFill>
                  <a:ln w="158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b-NO"/>
                  </a:p>
                </p:txBody>
              </p:sp>
              <p:sp>
                <p:nvSpPr>
                  <p:cNvPr id="44" name="TekstSylinder 43"/>
                  <p:cNvSpPr txBox="1"/>
                  <p:nvPr/>
                </p:nvSpPr>
                <p:spPr>
                  <a:xfrm>
                    <a:off x="2923246" y="3452686"/>
                    <a:ext cx="36004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nb-NO" sz="900" b="1" dirty="0" smtClean="0"/>
                      <a:t>F</a:t>
                    </a:r>
                    <a:endParaRPr lang="nb-NO" sz="900" b="1" dirty="0"/>
                  </a:p>
                </p:txBody>
              </p:sp>
            </p:grpSp>
            <p:sp>
              <p:nvSpPr>
                <p:cNvPr id="43" name="TekstSylinder 42"/>
                <p:cNvSpPr txBox="1"/>
                <p:nvPr/>
              </p:nvSpPr>
              <p:spPr>
                <a:xfrm>
                  <a:off x="4521375" y="2852936"/>
                  <a:ext cx="36004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nb-NO" sz="900" b="1" dirty="0" smtClean="0"/>
                    <a:t>G</a:t>
                  </a:r>
                  <a:endParaRPr lang="nb-NO" sz="900" b="1" dirty="0"/>
                </a:p>
              </p:txBody>
            </p:sp>
            <p:sp>
              <p:nvSpPr>
                <p:cNvPr id="47" name="Sylinder 46"/>
                <p:cNvSpPr/>
                <p:nvPr/>
              </p:nvSpPr>
              <p:spPr>
                <a:xfrm rot="16200000">
                  <a:off x="6600476" y="2174421"/>
                  <a:ext cx="153863" cy="1587856"/>
                </a:xfrm>
                <a:prstGeom prst="can">
                  <a:avLst/>
                </a:prstGeom>
                <a:gradFill flip="none" rotWithShape="1">
                  <a:gsLst>
                    <a:gs pos="0">
                      <a:schemeClr val="bg1">
                        <a:lumMod val="65000"/>
                      </a:schemeClr>
                    </a:gs>
                    <a:gs pos="50000">
                      <a:schemeClr val="accent1">
                        <a:tint val="44500"/>
                        <a:satMod val="160000"/>
                      </a:schemeClr>
                    </a:gs>
                    <a:gs pos="100000">
                      <a:schemeClr val="accent1">
                        <a:tint val="23500"/>
                        <a:satMod val="160000"/>
                      </a:schemeClr>
                    </a:gs>
                  </a:gsLst>
                  <a:lin ang="0" scaled="0"/>
                  <a:tileRect/>
                </a:gradFill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b-NO"/>
                </a:p>
              </p:txBody>
            </p:sp>
            <p:sp>
              <p:nvSpPr>
                <p:cNvPr id="48" name="TekstSylinder 47"/>
                <p:cNvSpPr txBox="1"/>
                <p:nvPr/>
              </p:nvSpPr>
              <p:spPr>
                <a:xfrm>
                  <a:off x="6581394" y="2852936"/>
                  <a:ext cx="36004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nb-NO" sz="900" b="1" dirty="0" smtClean="0"/>
                    <a:t>H</a:t>
                  </a:r>
                  <a:endParaRPr lang="nb-NO" sz="900" b="1" dirty="0"/>
                </a:p>
              </p:txBody>
            </p:sp>
          </p:grpSp>
          <p:cxnSp>
            <p:nvCxnSpPr>
              <p:cNvPr id="39" name="Rett linje 38"/>
              <p:cNvCxnSpPr/>
              <p:nvPr/>
            </p:nvCxnSpPr>
            <p:spPr>
              <a:xfrm flipV="1">
                <a:off x="5757519" y="4068000"/>
                <a:ext cx="137186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TekstSylinder 40"/>
            <p:cNvSpPr txBox="1"/>
            <p:nvPr/>
          </p:nvSpPr>
          <p:spPr>
            <a:xfrm>
              <a:off x="5709209" y="3736619"/>
              <a:ext cx="2838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11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M</a:t>
              </a:r>
              <a:endParaRPr lang="nb-NO" sz="1100" b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sp>
        <p:nvSpPr>
          <p:cNvPr id="24" name="TekstSylinder 23"/>
          <p:cNvSpPr txBox="1"/>
          <p:nvPr/>
        </p:nvSpPr>
        <p:spPr>
          <a:xfrm>
            <a:off x="899592" y="620688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nb-NO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b-NO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1</a:t>
            </a:r>
            <a:endParaRPr lang="nb-NO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6897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</TotalTime>
  <Words>50</Words>
  <Application>Microsoft Office PowerPoint</Application>
  <PresentationFormat>Skjermfremvisning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2" baseType="lpstr">
      <vt:lpstr>Office-tema</vt:lpstr>
      <vt:lpstr>PowerPoint-presentasjon</vt:lpstr>
    </vt:vector>
  </TitlesOfParts>
  <Company>Nofim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Øivind Andersen</dc:creator>
  <cp:lastModifiedBy>Øivind Andersen</cp:lastModifiedBy>
  <cp:revision>18</cp:revision>
  <dcterms:created xsi:type="dcterms:W3CDTF">2013-10-09T09:31:18Z</dcterms:created>
  <dcterms:modified xsi:type="dcterms:W3CDTF">2013-10-29T21:29:13Z</dcterms:modified>
</cp:coreProperties>
</file>